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D2302-65FB-40C5-A65A-14FCD97C08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EE6A43-3096-4245-9C8F-B0491F3525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CBCA2-1216-44CC-AC2D-7D818AC980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979E2A-D0A3-49A5-8D84-106A746355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7747C-B0F7-4C82-B825-E459843005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5E86B-CC37-4C81-B36A-5CAE4C6AFD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93FDD-69E4-44CA-86BB-604A8823AD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02CB7-5B89-4839-A4C3-70F8679880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97DAD-0C9C-4AAE-8F39-82AF46BD86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73754-C3AC-45F6-8E68-EFCE48669A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CAA8E-B56B-4CDE-B390-7BD847E0F7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2A29D1-EC29-4956-823F-E88B5C7AA8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A53EDF-C368-4F4B-BA88-98965E2F509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96760" y="979560"/>
            <a:ext cx="7445160" cy="1887480"/>
            <a:chOff x="896760" y="979560"/>
            <a:chExt cx="7445160" cy="1887480"/>
          </a:xfrm>
        </p:grpSpPr>
        <p:grpSp>
          <p:nvGrpSpPr>
            <p:cNvPr id="42" name=""/>
            <p:cNvGrpSpPr/>
            <p:nvPr/>
          </p:nvGrpSpPr>
          <p:grpSpPr>
            <a:xfrm>
              <a:off x="1050840" y="979560"/>
              <a:ext cx="7291080" cy="1887480"/>
              <a:chOff x="1050840" y="979560"/>
              <a:chExt cx="7291080" cy="188748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rcRect l="6515" t="54333" r="13495" b="9898"/>
              <a:stretch/>
            </p:blipFill>
            <p:spPr>
              <a:xfrm>
                <a:off x="2820960" y="1446120"/>
                <a:ext cx="4716360" cy="1420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"/>
              <p:cNvSpPr/>
              <p:nvPr/>
            </p:nvSpPr>
            <p:spPr>
              <a:xfrm>
                <a:off x="1050840" y="1141560"/>
                <a:ext cx="1920960" cy="1692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75000"/>
                  </a:lnSpc>
                  <a:tabLst>
                    <a:tab algn="l" pos="0"/>
                    <a:tab algn="ctr" pos="399960"/>
                    <a:tab algn="ctr" pos="1143000"/>
                    <a:tab algn="ctr" pos="16002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azole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µg/ml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75000"/>
                  </a:lnSpc>
                  <a:tabLst>
                    <a:tab algn="l" pos="0"/>
                    <a:tab algn="ctr" pos="399960"/>
                    <a:tab algn="ctr" pos="1143000"/>
                    <a:tab algn="ctr" pos="16002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etoconazole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001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9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75000"/>
                  </a:lnSpc>
                  <a:tabLst>
                    <a:tab algn="l" pos="0"/>
                    <a:tab algn="ctr" pos="399960"/>
                    <a:tab algn="ctr" pos="1143000"/>
                    <a:tab algn="ctr" pos="16002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lotrimazole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002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8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75000"/>
                  </a:lnSpc>
                  <a:tabLst>
                    <a:tab algn="l" pos="0"/>
                    <a:tab algn="ctr" pos="399960"/>
                    <a:tab algn="ctr" pos="1143000"/>
                    <a:tab algn="ctr" pos="16002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econa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z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ole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025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9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75000"/>
                  </a:lnSpc>
                  <a:tabLst>
                    <a:tab algn="l" pos="0"/>
                    <a:tab algn="ctr" pos="399960"/>
                    <a:tab algn="ctr" pos="1143000"/>
                    <a:tab algn="ctr" pos="16002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ulconazole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005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7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75000"/>
                  </a:lnSpc>
                  <a:tabLst>
                    <a:tab algn="l" pos="0"/>
                    <a:tab algn="ctr" pos="399960"/>
                    <a:tab algn="ctr" pos="1143000"/>
                    <a:tab algn="ctr" pos="16002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voriconazole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002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8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5" name="" descr=""/>
              <p:cNvPicPr/>
              <p:nvPr/>
            </p:nvPicPr>
            <p:blipFill>
              <a:blip r:embed="rId2"/>
              <a:srcRect l="6302" t="3599" r="12603" b="84898"/>
              <a:stretch/>
            </p:blipFill>
            <p:spPr>
              <a:xfrm>
                <a:off x="2800440" y="979560"/>
                <a:ext cx="4781520" cy="457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"/>
              <p:cNvSpPr/>
              <p:nvPr/>
            </p:nvSpPr>
            <p:spPr>
              <a:xfrm>
                <a:off x="7659720" y="1647720"/>
                <a:ext cx="682200" cy="750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2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ERG1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2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NCP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2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CDR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7583400" y="2187720"/>
                <a:ext cx="123840" cy="123840"/>
              </a:xfrm>
              <a:prstGeom prst="diamond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120" bIns="151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7593120" y="1758960"/>
                <a:ext cx="109440" cy="1094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0960" bIns="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7593120" y="1978200"/>
                <a:ext cx="109440" cy="1094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0960" bIns="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0" name=""/>
            <p:cNvSpPr/>
            <p:nvPr/>
          </p:nvSpPr>
          <p:spPr>
            <a:xfrm>
              <a:off x="896760" y="988920"/>
              <a:ext cx="184320" cy="33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" name=""/>
          <p:cNvSpPr/>
          <p:nvPr/>
        </p:nvSpPr>
        <p:spPr>
          <a:xfrm>
            <a:off x="1044720" y="3294000"/>
            <a:ext cx="7294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 S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imidazoles (ketoconazole, clotrimazole, econ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z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le and sulconazole) and a triazole (voriconazole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0T20:57:52Z</dcterms:created>
  <dc:creator>xudemin</dc:creator>
  <dc:description/>
  <dc:language>en-US</dc:language>
  <cp:lastModifiedBy>xudemin</cp:lastModifiedBy>
  <dcterms:modified xsi:type="dcterms:W3CDTF">2007-05-17T14:05:42Z</dcterms:modified>
  <cp:revision>3</cp:revision>
  <dc:subject/>
  <dc:title>Slide 1</dc:title>
</cp:coreProperties>
</file>